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059706"/>
              </p:ext>
            </p:extLst>
          </p:nvPr>
        </p:nvGraphicFramePr>
        <p:xfrm>
          <a:off x="1548130" y="1243107"/>
          <a:ext cx="5864860" cy="112458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72845"/>
                <a:gridCol w="1172845"/>
                <a:gridCol w="1172845"/>
                <a:gridCol w="1172845"/>
                <a:gridCol w="1173480"/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5mg overnight spin column 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uregene 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01625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ample</a:t>
                      </a:r>
                      <a:endParaRPr lang="en-US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Original </a:t>
                      </a:r>
                      <a:endParaRPr lang="en-US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re-digested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riginal 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re-digested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2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56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5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94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90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4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61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53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89</a:t>
                      </a:r>
                      <a:endParaRPr lang="en-US" sz="12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84</a:t>
                      </a:r>
                      <a:endParaRPr lang="en-US" sz="12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403604" y="2512582"/>
            <a:ext cx="63367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dirty="0">
                <a:latin typeface="+mj-lt"/>
                <a:ea typeface="ＭＳ 明朝" charset="-128"/>
                <a:cs typeface="Segoe UI" charset="0"/>
              </a:rPr>
              <a:t>Table </a:t>
            </a:r>
            <a:r>
              <a:rPr lang="en-US" sz="1200" b="1" dirty="0" smtClean="0">
                <a:latin typeface="+mj-lt"/>
                <a:ea typeface="ＭＳ 明朝" charset="-128"/>
                <a:cs typeface="Segoe UI" charset="0"/>
              </a:rPr>
              <a:t>S5. </a:t>
            </a:r>
            <a:r>
              <a:rPr lang="en-US" sz="1200" b="1" i="1" dirty="0">
                <a:latin typeface="+mj-lt"/>
                <a:ea typeface="ＭＳ 明朝" charset="-128"/>
                <a:cs typeface="Segoe UI" charset="0"/>
              </a:rPr>
              <a:t>TSC2 </a:t>
            </a:r>
            <a:r>
              <a:rPr lang="en-US" sz="1200" b="1" dirty="0">
                <a:latin typeface="+mj-lt"/>
                <a:ea typeface="ＭＳ 明朝" charset="-128"/>
                <a:cs typeface="Segoe UI" charset="0"/>
              </a:rPr>
              <a:t>CN in ddPCR performed with and without restriction digestion as a separate step. </a:t>
            </a:r>
            <a:endParaRPr lang="en-US" sz="1200" dirty="0">
              <a:latin typeface="+mj-lt"/>
              <a:ea typeface="ＭＳ 明朝" charset="-128"/>
              <a:cs typeface="Segoe UI" charset="0"/>
            </a:endParaRPr>
          </a:p>
          <a:p>
            <a:pPr>
              <a:spcAft>
                <a:spcPts val="0"/>
              </a:spcAft>
            </a:pPr>
            <a:endParaRPr lang="en-US" sz="1200" dirty="0">
              <a:effectLst/>
              <a:latin typeface="+mj-lt"/>
              <a:ea typeface="ＭＳ 明朝" charset="-128"/>
              <a:cs typeface="Segoe U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0431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6</TotalTime>
  <Words>38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Calibri</vt:lpstr>
      <vt:lpstr>Cambria</vt:lpstr>
      <vt:lpstr>ＭＳ 明朝</vt:lpstr>
      <vt:lpstr>Segoe UI</vt:lpstr>
      <vt:lpstr>Times New Roman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52:32Z</dcterms:modified>
</cp:coreProperties>
</file>